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5" autoAdjust="0"/>
    <p:restoredTop sz="94660"/>
  </p:normalViewPr>
  <p:slideViewPr>
    <p:cSldViewPr snapToGrid="0">
      <p:cViewPr varScale="1">
        <p:scale>
          <a:sx n="52" d="100"/>
          <a:sy n="52" d="100"/>
        </p:scale>
        <p:origin x="2214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t-BR" smtClean="0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DECA2-809F-4FB3-BC4C-E527EB006F0E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D6370-FD23-4D43-8D03-31D4A536BFAC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8229342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DECA2-809F-4FB3-BC4C-E527EB006F0E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D6370-FD23-4D43-8D03-31D4A536BFAC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701606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DECA2-809F-4FB3-BC4C-E527EB006F0E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D6370-FD23-4D43-8D03-31D4A536BFAC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7431387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DECA2-809F-4FB3-BC4C-E527EB006F0E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D6370-FD23-4D43-8D03-31D4A536BFAC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8601921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DECA2-809F-4FB3-BC4C-E527EB006F0E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D6370-FD23-4D43-8D03-31D4A536BFAC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473016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DECA2-809F-4FB3-BC4C-E527EB006F0E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D6370-FD23-4D43-8D03-31D4A536BFAC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2643673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DECA2-809F-4FB3-BC4C-E527EB006F0E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D6370-FD23-4D43-8D03-31D4A536BFAC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0208511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DECA2-809F-4FB3-BC4C-E527EB006F0E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D6370-FD23-4D43-8D03-31D4A536BFAC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881865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DECA2-809F-4FB3-BC4C-E527EB006F0E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D6370-FD23-4D43-8D03-31D4A536BFAC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8683323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DECA2-809F-4FB3-BC4C-E527EB006F0E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D6370-FD23-4D43-8D03-31D4A536BFAC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8736184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t-BR" smtClean="0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DECA2-809F-4FB3-BC4C-E527EB006F0E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D6370-FD23-4D43-8D03-31D4A536BFAC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9322835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6DECA2-809F-4FB3-BC4C-E527EB006F0E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8D6370-FD23-4D43-8D03-31D4A536BFAC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8744572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543" y="29487"/>
            <a:ext cx="5406108" cy="2583815"/>
          </a:xfrm>
          <a:prstGeom prst="rect">
            <a:avLst/>
          </a:prstGeom>
        </p:spPr>
      </p:pic>
      <p:pic>
        <p:nvPicPr>
          <p:cNvPr id="5" name="Picture 5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5528" y="2682331"/>
            <a:ext cx="5406108" cy="2938780"/>
          </a:xfrm>
          <a:prstGeom prst="rect">
            <a:avLst/>
          </a:prstGeom>
        </p:spPr>
      </p:pic>
      <p:pic>
        <p:nvPicPr>
          <p:cNvPr id="6" name="Picture 6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3223" y="5700773"/>
            <a:ext cx="5357495" cy="2914016"/>
          </a:xfrm>
          <a:prstGeom prst="rect">
            <a:avLst/>
          </a:prstGeom>
        </p:spPr>
      </p:pic>
      <p:sp>
        <p:nvSpPr>
          <p:cNvPr id="7" name="Caixa de Texto 2"/>
          <p:cNvSpPr txBox="1">
            <a:spLocks noChangeArrowheads="1"/>
          </p:cNvSpPr>
          <p:nvPr/>
        </p:nvSpPr>
        <p:spPr bwMode="auto">
          <a:xfrm>
            <a:off x="6044" y="5924372"/>
            <a:ext cx="492550" cy="418706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132080" tIns="66041" rIns="132080" bIns="66041" anchor="t" anchorCtr="0">
            <a:spAutoFit/>
          </a:bodyPr>
          <a:lstStyle/>
          <a:p>
            <a:pPr>
              <a:lnSpc>
                <a:spcPct val="107000"/>
              </a:lnSpc>
              <a:spcAft>
                <a:spcPts val="1156"/>
              </a:spcAft>
            </a:pPr>
            <a:r>
              <a:rPr lang="pt-BR" sz="1733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endParaRPr lang="pt-BR" sz="1589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8" name="Caixa de Texto 2"/>
          <p:cNvSpPr txBox="1">
            <a:spLocks noChangeArrowheads="1"/>
          </p:cNvSpPr>
          <p:nvPr/>
        </p:nvSpPr>
        <p:spPr bwMode="auto">
          <a:xfrm>
            <a:off x="22206" y="2794468"/>
            <a:ext cx="492550" cy="418706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132080" tIns="66041" rIns="132080" bIns="66041" anchor="t" anchorCtr="0">
            <a:spAutoFit/>
          </a:bodyPr>
          <a:lstStyle/>
          <a:p>
            <a:pPr>
              <a:lnSpc>
                <a:spcPct val="107000"/>
              </a:lnSpc>
              <a:spcAft>
                <a:spcPts val="1156"/>
              </a:spcAft>
            </a:pPr>
            <a:r>
              <a:rPr lang="pt-BR" sz="1733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endParaRPr lang="pt-BR" sz="1589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9" name="Caixa de Texto 2"/>
          <p:cNvSpPr txBox="1">
            <a:spLocks noChangeArrowheads="1"/>
          </p:cNvSpPr>
          <p:nvPr/>
        </p:nvSpPr>
        <p:spPr bwMode="auto">
          <a:xfrm>
            <a:off x="6041" y="254788"/>
            <a:ext cx="492550" cy="418706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132080" tIns="66041" rIns="132080" bIns="66041" anchor="t" anchorCtr="0">
            <a:spAutoFit/>
          </a:bodyPr>
          <a:lstStyle/>
          <a:p>
            <a:pPr>
              <a:lnSpc>
                <a:spcPct val="107000"/>
              </a:lnSpc>
              <a:spcAft>
                <a:spcPts val="1156"/>
              </a:spcAft>
            </a:pPr>
            <a:r>
              <a:rPr lang="pt-BR" sz="1733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endParaRPr lang="pt-BR" sz="1589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Grupo 9"/>
          <p:cNvGrpSpPr/>
          <p:nvPr/>
        </p:nvGrpSpPr>
        <p:grpSpPr>
          <a:xfrm>
            <a:off x="5852924" y="6456559"/>
            <a:ext cx="1554176" cy="910053"/>
            <a:chOff x="229170" y="63755"/>
            <a:chExt cx="1077588" cy="630488"/>
          </a:xfrm>
        </p:grpSpPr>
        <p:sp>
          <p:nvSpPr>
            <p:cNvPr id="11" name="Left Arrow 8"/>
            <p:cNvSpPr/>
            <p:nvPr/>
          </p:nvSpPr>
          <p:spPr>
            <a:xfrm>
              <a:off x="229170" y="376624"/>
              <a:ext cx="174339" cy="125974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pt-BR" sz="2601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316017" y="325220"/>
              <a:ext cx="613517" cy="20256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52282"/>
              <a:r>
                <a:rPr lang="en-US" sz="13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∼52 </a:t>
              </a:r>
              <a:r>
                <a:rPr lang="en-US" sz="1300" dirty="0" err="1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kDa</a:t>
              </a:r>
              <a:endParaRPr lang="pt-BR" sz="13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3" name="Rectangle 13"/>
            <p:cNvSpPr/>
            <p:nvPr/>
          </p:nvSpPr>
          <p:spPr>
            <a:xfrm>
              <a:off x="409694" y="491675"/>
              <a:ext cx="656139" cy="20256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52282"/>
              <a:r>
                <a:rPr lang="en-US" sz="1300" dirty="0" err="1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RbcL</a:t>
              </a:r>
              <a:endParaRPr lang="pt-BR" sz="13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4" name="Rectangle 16"/>
            <p:cNvSpPr/>
            <p:nvPr/>
          </p:nvSpPr>
          <p:spPr>
            <a:xfrm>
              <a:off x="236609" y="63755"/>
              <a:ext cx="1070149" cy="20256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52282"/>
              <a:r>
                <a:rPr lang="en-US" sz="1300" b="1" dirty="0" err="1" smtClean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Rubisco</a:t>
              </a:r>
              <a:endParaRPr lang="pt-BR" sz="13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</p:grpSp>
      <p:sp>
        <p:nvSpPr>
          <p:cNvPr id="15" name="Retângulo 14"/>
          <p:cNvSpPr/>
          <p:nvPr/>
        </p:nvSpPr>
        <p:spPr>
          <a:xfrm>
            <a:off x="1" y="8598289"/>
            <a:ext cx="6858000" cy="13665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Bef>
                <a:spcPts val="3467"/>
              </a:spcBef>
            </a:pPr>
            <a:r>
              <a:rPr lang="en-US" sz="1200" b="1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sz="1200" b="1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200" b="1" kern="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evels of </a:t>
            </a:r>
            <a:r>
              <a:rPr lang="en-US" sz="1200" kern="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ubisco</a:t>
            </a:r>
            <a:r>
              <a:rPr lang="en-US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large subunit (</a:t>
            </a:r>
            <a:r>
              <a:rPr lang="en-US" sz="1200" kern="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bcL</a:t>
            </a:r>
            <a:r>
              <a:rPr lang="en-US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in 4-week-old plants from two ILs of </a:t>
            </a:r>
            <a:r>
              <a:rPr lang="en-US" sz="1200" i="1" kern="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olanum</a:t>
            </a:r>
            <a:r>
              <a:rPr lang="en-US" sz="1200" i="1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kern="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ennellii</a:t>
            </a:r>
            <a:r>
              <a:rPr lang="en-US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to a genetic background of </a:t>
            </a:r>
            <a:r>
              <a:rPr lang="en-US" sz="1200" i="1" kern="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olanum</a:t>
            </a:r>
            <a:r>
              <a:rPr lang="en-US" sz="1200" i="1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kern="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ycopersicum</a:t>
            </a:r>
            <a:r>
              <a:rPr lang="en-US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M82) grown at 400 µ</a:t>
            </a:r>
            <a:r>
              <a:rPr lang="en-US" sz="1200" kern="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ol</a:t>
            </a:r>
            <a:r>
              <a:rPr lang="en-US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O</a:t>
            </a:r>
            <a:r>
              <a:rPr lang="en-US" sz="1200" kern="0" baseline="-25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ol</a:t>
            </a:r>
            <a:r>
              <a:rPr lang="en-US" sz="1200" kern="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ir. Protein was loaded on a 12% SDS-PAGE and further stained with </a:t>
            </a:r>
            <a:r>
              <a:rPr lang="en-US" sz="1200" kern="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omassie</a:t>
            </a:r>
            <a:r>
              <a:rPr lang="en-US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rilliant blue </a:t>
            </a:r>
            <a:r>
              <a:rPr lang="en-US" sz="1200" b="1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; Nitrocellulose membrane stained with </a:t>
            </a:r>
            <a:r>
              <a:rPr lang="en-US" sz="1200" kern="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onceau</a:t>
            </a:r>
            <a:r>
              <a:rPr lang="en-US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; Nitrocellulose membrane revealed with 3,3′-diaminobenzidine (DAB) </a:t>
            </a:r>
            <a:r>
              <a:rPr lang="en-US" sz="1200" b="1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US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kern="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bcL</a:t>
            </a:r>
            <a:r>
              <a:rPr lang="en-US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esignates the large subunit of ribulose-1,5-bisphosphate carboxylase/</a:t>
            </a:r>
            <a:r>
              <a:rPr lang="en-US" sz="1200" kern="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xygenase</a:t>
            </a:r>
            <a:r>
              <a:rPr lang="en-US" sz="1200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pt-BR" sz="1200" b="1" kern="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633183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20</TotalTime>
  <Words>95</Words>
  <Application>Microsoft Office PowerPoint</Application>
  <PresentationFormat>Papel A4 (210 x 297 mm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Cliente</dc:creator>
  <cp:lastModifiedBy>Cliente</cp:lastModifiedBy>
  <cp:revision>13</cp:revision>
  <dcterms:created xsi:type="dcterms:W3CDTF">2019-04-29T12:01:30Z</dcterms:created>
  <dcterms:modified xsi:type="dcterms:W3CDTF">2020-05-01T01:19:59Z</dcterms:modified>
</cp:coreProperties>
</file>